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DA570-949B-4749-9C2C-02C69F5240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CE61D-C393-443A-833C-0C3740557F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FD605-2676-405C-B8EB-AD2603035C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234938-BE16-4C48-80E6-6DD55B7494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F1562-CA44-4FB5-AD41-72D98489BA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B9AD1-4CBE-4D3E-A5A3-618230BFC6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2E2F2-A86D-44AA-9595-EB7CEA5C6A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9F88C-D2ED-4560-A539-EC5F656480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17D67-C6E9-484B-B173-FB4B12A146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F1871-631C-4299-80BB-AF68D760E9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4C164-814F-48B8-8390-9866FD0721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1678A-45B8-4E0B-85B8-AD6FB5FB9E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2FBDCF-AA8F-44A1-8663-DA8CC7011C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56" descr=""/>
          <p:cNvPicPr/>
          <p:nvPr/>
        </p:nvPicPr>
        <p:blipFill>
          <a:blip r:embed="rId1"/>
          <a:stretch/>
        </p:blipFill>
        <p:spPr>
          <a:xfrm>
            <a:off x="1066680" y="1447920"/>
            <a:ext cx="7086600" cy="2452680"/>
          </a:xfrm>
          <a:prstGeom prst="rect">
            <a:avLst/>
          </a:prstGeom>
          <a:ln w="0">
            <a:noFill/>
          </a:ln>
        </p:spPr>
      </p:pic>
      <p:sp>
        <p:nvSpPr>
          <p:cNvPr id="42" name="TextBox 257"/>
          <p:cNvSpPr/>
          <p:nvPr/>
        </p:nvSpPr>
        <p:spPr>
          <a:xfrm>
            <a:off x="5867280" y="990720"/>
            <a:ext cx="1295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% of HLA-DR+CD11c+ MDD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259"/>
          <p:cNvSpPr/>
          <p:nvPr/>
        </p:nvSpPr>
        <p:spPr>
          <a:xfrm>
            <a:off x="7010280" y="990720"/>
            <a:ext cx="1295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xpression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LA-AB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260"/>
          <p:cNvSpPr/>
          <p:nvPr/>
        </p:nvSpPr>
        <p:spPr>
          <a:xfrm>
            <a:off x="304920" y="1600200"/>
            <a:ext cx="838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D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b stain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61"/>
          <p:cNvSpPr/>
          <p:nvPr/>
        </p:nvSpPr>
        <p:spPr>
          <a:xfrm>
            <a:off x="304920" y="3124080"/>
            <a:ext cx="838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D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ckgrou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5200" y="45720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04920" y="2666880"/>
            <a:ext cx="8381880" cy="1752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1T19:11:01Z</dcterms:created>
  <dc:creator>Tiger</dc:creator>
  <dc:description/>
  <dc:language>en-US</dc:language>
  <cp:lastModifiedBy>Tiger</cp:lastModifiedBy>
  <dcterms:modified xsi:type="dcterms:W3CDTF">2011-10-14T13:44:28Z</dcterms:modified>
  <cp:revision>4</cp:revision>
  <dc:subject/>
  <dc:title>Slide 1</dc:title>
</cp:coreProperties>
</file>